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12192000" cy="108172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526"/>
    <p:restoredTop sz="94729"/>
  </p:normalViewPr>
  <p:slideViewPr>
    <p:cSldViewPr snapToGrid="0">
      <p:cViewPr>
        <p:scale>
          <a:sx n="105" d="100"/>
          <a:sy n="105" d="100"/>
        </p:scale>
        <p:origin x="912" y="-18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ssimo Iavarone" userId="6b9a2704f3d84d82" providerId="LiveId" clId="{6044045A-4346-50E4-81FE-07A17CD77F21}"/>
    <pc:docChg chg="undo custSel modSld">
      <pc:chgData name="Massimo Iavarone" userId="6b9a2704f3d84d82" providerId="LiveId" clId="{6044045A-4346-50E4-81FE-07A17CD77F21}" dt="2025-12-20T16:27:09.935" v="2" actId="478"/>
      <pc:docMkLst>
        <pc:docMk/>
      </pc:docMkLst>
      <pc:sldChg chg="addSp delSp mod">
        <pc:chgData name="Massimo Iavarone" userId="6b9a2704f3d84d82" providerId="LiveId" clId="{6044045A-4346-50E4-81FE-07A17CD77F21}" dt="2025-12-20T16:27:09.935" v="2" actId="478"/>
        <pc:sldMkLst>
          <pc:docMk/>
          <pc:sldMk cId="2793512956" sldId="256"/>
        </pc:sldMkLst>
        <pc:spChg chg="add del">
          <ac:chgData name="Massimo Iavarone" userId="6b9a2704f3d84d82" providerId="LiveId" clId="{6044045A-4346-50E4-81FE-07A17CD77F21}" dt="2025-12-20T16:27:09.935" v="2" actId="478"/>
          <ac:spMkLst>
            <pc:docMk/>
            <pc:sldMk cId="2793512956" sldId="256"/>
            <ac:spMk id="2" creationId="{F4C0021D-AB3C-2856-F113-663584E8AF78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770320"/>
            <a:ext cx="10363200" cy="376599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5681548"/>
            <a:ext cx="9144000" cy="2611658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EA481-E1A6-8A48-BD9E-FC3EDE6632EA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8E64-BE19-DF4E-81F0-7B33050E8E2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0689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EA481-E1A6-8A48-BD9E-FC3EDE6632EA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8E64-BE19-DF4E-81F0-7B33050E8E2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06280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575917"/>
            <a:ext cx="2628900" cy="916709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575917"/>
            <a:ext cx="7734300" cy="916709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EA481-E1A6-8A48-BD9E-FC3EDE6632EA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8E64-BE19-DF4E-81F0-7B33050E8E2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68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EA481-E1A6-8A48-BD9E-FC3EDE6632EA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8E64-BE19-DF4E-81F0-7B33050E8E2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35554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696798"/>
            <a:ext cx="10515600" cy="4499664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7239030"/>
            <a:ext cx="10515600" cy="2366267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82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EA481-E1A6-8A48-BD9E-FC3EDE6632EA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8E64-BE19-DF4E-81F0-7B33050E8E2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3952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879585"/>
            <a:ext cx="5181600" cy="6863430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879585"/>
            <a:ext cx="5181600" cy="6863430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EA481-E1A6-8A48-BD9E-FC3EDE6632EA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8E64-BE19-DF4E-81F0-7B33050E8E2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55536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75920"/>
            <a:ext cx="10515600" cy="2090830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651723"/>
            <a:ext cx="5157787" cy="129956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951292"/>
            <a:ext cx="5157787" cy="5811755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651723"/>
            <a:ext cx="5183188" cy="129956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951292"/>
            <a:ext cx="5183188" cy="5811755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EA481-E1A6-8A48-BD9E-FC3EDE6632EA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8E64-BE19-DF4E-81F0-7B33050E8E2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49509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EA481-E1A6-8A48-BD9E-FC3EDE6632EA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8E64-BE19-DF4E-81F0-7B33050E8E2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9270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EA481-E1A6-8A48-BD9E-FC3EDE6632EA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8E64-BE19-DF4E-81F0-7B33050E8E2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77974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21148"/>
            <a:ext cx="3932237" cy="252401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557482"/>
            <a:ext cx="6172200" cy="7687241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245168"/>
            <a:ext cx="3932237" cy="6012074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EA481-E1A6-8A48-BD9E-FC3EDE6632EA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8E64-BE19-DF4E-81F0-7B33050E8E2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21604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21148"/>
            <a:ext cx="3932237" cy="252401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557482"/>
            <a:ext cx="6172200" cy="7687241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245168"/>
            <a:ext cx="3932237" cy="6012074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EA481-E1A6-8A48-BD9E-FC3EDE6632EA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8E64-BE19-DF4E-81F0-7B33050E8E2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14348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575920"/>
            <a:ext cx="10515600" cy="20908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879585"/>
            <a:ext cx="10515600" cy="686343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0025967"/>
            <a:ext cx="2743200" cy="575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34EA481-E1A6-8A48-BD9E-FC3EDE6632EA}" type="datetimeFigureOut">
              <a:rPr lang="en-GB" smtClean="0"/>
              <a:t>23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0025967"/>
            <a:ext cx="4114800" cy="575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0025967"/>
            <a:ext cx="2743200" cy="575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87F8E64-BE19-DF4E-81F0-7B33050E8E29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85368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ottotitolo 2">
            <a:extLst>
              <a:ext uri="{FF2B5EF4-FFF2-40B4-BE49-F238E27FC236}">
                <a16:creationId xmlns:a16="http://schemas.microsoft.com/office/drawing/2014/main" id="{DD00CB33-E48F-B9CB-629A-DDE4206524E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2127067" y="3275013"/>
            <a:ext cx="9144000" cy="1655762"/>
          </a:xfrm>
        </p:spPr>
        <p:txBody>
          <a:bodyPr/>
          <a:lstStyle/>
          <a:p>
            <a:endParaRPr lang="en-GB"/>
          </a:p>
        </p:txBody>
      </p:sp>
      <p:pic>
        <p:nvPicPr>
          <p:cNvPr id="4" name="Immagine 3" descr="Immagine che contiene testo, diagramma, linea, schermata&#10;&#10;Il contenuto generato dall'IA potrebbe non essere corretto.">
            <a:extLst>
              <a:ext uri="{FF2B5EF4-FFF2-40B4-BE49-F238E27FC236}">
                <a16:creationId xmlns:a16="http://schemas.microsoft.com/office/drawing/2014/main" id="{D542279A-B2A3-C324-94EE-4BD14D2D36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3067" y="1139825"/>
            <a:ext cx="5691716" cy="4268787"/>
          </a:xfrm>
          <a:prstGeom prst="rect">
            <a:avLst/>
          </a:prstGeom>
        </p:spPr>
      </p:pic>
      <p:pic>
        <p:nvPicPr>
          <p:cNvPr id="5" name="Immagine 4" descr="Immagine che contiene testo, diagramma, linea, Diagramma&#10;&#10;Il contenuto generato dall'IA potrebbe non essere corretto.">
            <a:extLst>
              <a:ext uri="{FF2B5EF4-FFF2-40B4-BE49-F238E27FC236}">
                <a16:creationId xmlns:a16="http://schemas.microsoft.com/office/drawing/2014/main" id="{C8FE7386-537F-EB2C-B638-ECE3F9C1FD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26237" y="1139824"/>
            <a:ext cx="5692666" cy="4268786"/>
          </a:xfrm>
          <a:prstGeom prst="rect">
            <a:avLst/>
          </a:prstGeom>
        </p:spPr>
      </p:pic>
      <p:pic>
        <p:nvPicPr>
          <p:cNvPr id="7" name="Immagine 6" descr="Immagine che contiene diagramma, linea, testo, Piano&#10;&#10;Il contenuto generato dall'IA potrebbe non essere corretto.">
            <a:extLst>
              <a:ext uri="{FF2B5EF4-FFF2-40B4-BE49-F238E27FC236}">
                <a16:creationId xmlns:a16="http://schemas.microsoft.com/office/drawing/2014/main" id="{10798CC2-8BAE-99F7-ADE3-416F7B3366D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3066" y="6064594"/>
            <a:ext cx="5691715" cy="4268786"/>
          </a:xfrm>
          <a:prstGeom prst="rect">
            <a:avLst/>
          </a:prstGeom>
        </p:spPr>
      </p:pic>
      <p:pic>
        <p:nvPicPr>
          <p:cNvPr id="9" name="Immagine 8" descr="Immagine che contiene diagramma, linea, testo, Diagramma&#10;&#10;Il contenuto generato dall'IA potrebbe non essere corretto.">
            <a:extLst>
              <a:ext uri="{FF2B5EF4-FFF2-40B4-BE49-F238E27FC236}">
                <a16:creationId xmlns:a16="http://schemas.microsoft.com/office/drawing/2014/main" id="{DA333BFF-4D58-228B-6E1E-62C6E6A582C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26236" y="6064594"/>
            <a:ext cx="5691715" cy="4268786"/>
          </a:xfrm>
          <a:prstGeom prst="rect">
            <a:avLst/>
          </a:prstGeom>
        </p:spPr>
      </p:pic>
      <p:sp>
        <p:nvSpPr>
          <p:cNvPr id="10" name="CasellaDiTesto 9">
            <a:extLst>
              <a:ext uri="{FF2B5EF4-FFF2-40B4-BE49-F238E27FC236}">
                <a16:creationId xmlns:a16="http://schemas.microsoft.com/office/drawing/2014/main" id="{B6AE0475-22B9-D707-DF43-DB7D6D2BB29C}"/>
              </a:ext>
            </a:extLst>
          </p:cNvPr>
          <p:cNvSpPr txBox="1"/>
          <p:nvPr/>
        </p:nvSpPr>
        <p:spPr>
          <a:xfrm>
            <a:off x="173097" y="955158"/>
            <a:ext cx="1152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5C78B6BD-21CD-160D-CC42-B990320A80CB}"/>
              </a:ext>
            </a:extLst>
          </p:cNvPr>
          <p:cNvSpPr txBox="1"/>
          <p:nvPr/>
        </p:nvSpPr>
        <p:spPr>
          <a:xfrm>
            <a:off x="5902474" y="955158"/>
            <a:ext cx="1152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966817FD-40CA-F895-3348-DD8A6C6BF3D5}"/>
              </a:ext>
            </a:extLst>
          </p:cNvPr>
          <p:cNvSpPr txBox="1"/>
          <p:nvPr/>
        </p:nvSpPr>
        <p:spPr>
          <a:xfrm>
            <a:off x="173096" y="5879928"/>
            <a:ext cx="1152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4F9AEFA3-153A-AF1C-BFE8-417893B7AEE5}"/>
              </a:ext>
            </a:extLst>
          </p:cNvPr>
          <p:cNvSpPr txBox="1"/>
          <p:nvPr/>
        </p:nvSpPr>
        <p:spPr>
          <a:xfrm>
            <a:off x="5902474" y="5886450"/>
            <a:ext cx="1152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D</a:t>
            </a:r>
          </a:p>
        </p:txBody>
      </p:sp>
      <p:sp>
        <p:nvSpPr>
          <p:cNvPr id="2" name="Rettangolo 1">
            <a:extLst>
              <a:ext uri="{FF2B5EF4-FFF2-40B4-BE49-F238E27FC236}">
                <a16:creationId xmlns:a16="http://schemas.microsoft.com/office/drawing/2014/main" id="{CA76D196-38BD-7636-779C-06237ADB79B9}"/>
              </a:ext>
            </a:extLst>
          </p:cNvPr>
          <p:cNvSpPr/>
          <p:nvPr/>
        </p:nvSpPr>
        <p:spPr>
          <a:xfrm>
            <a:off x="2795239" y="1139824"/>
            <a:ext cx="1085385" cy="34700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A5C100CC-F2A1-2178-36BB-36EAAF28AC6D}"/>
              </a:ext>
            </a:extLst>
          </p:cNvPr>
          <p:cNvSpPr txBox="1"/>
          <p:nvPr/>
        </p:nvSpPr>
        <p:spPr>
          <a:xfrm>
            <a:off x="2965480" y="1113271"/>
            <a:ext cx="8697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/>
              <a:t>OS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F5B4D68A-A0FD-C852-9720-EF022EC8C04E}"/>
              </a:ext>
            </a:extLst>
          </p:cNvPr>
          <p:cNvSpPr txBox="1"/>
          <p:nvPr/>
        </p:nvSpPr>
        <p:spPr>
          <a:xfrm>
            <a:off x="1092565" y="3872061"/>
            <a:ext cx="280307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/PD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.6 months (95% CI, 11.6–15.6)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/PR: 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E (95% CI: NE-NE)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E8508550-725E-430B-6B9B-D834A59D77E6}"/>
              </a:ext>
            </a:extLst>
          </p:cNvPr>
          <p:cNvSpPr txBox="1"/>
          <p:nvPr/>
        </p:nvSpPr>
        <p:spPr>
          <a:xfrm>
            <a:off x="6877669" y="3872060"/>
            <a:ext cx="25394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/PD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6 months (95% CI 3.0–4.6) </a:t>
            </a: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/PR: 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E (95% CI: NE-NE)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ttangolo 14">
            <a:extLst>
              <a:ext uri="{FF2B5EF4-FFF2-40B4-BE49-F238E27FC236}">
                <a16:creationId xmlns:a16="http://schemas.microsoft.com/office/drawing/2014/main" id="{215047EC-F708-578E-EBA3-E7CC956CC769}"/>
              </a:ext>
            </a:extLst>
          </p:cNvPr>
          <p:cNvSpPr/>
          <p:nvPr/>
        </p:nvSpPr>
        <p:spPr>
          <a:xfrm>
            <a:off x="8753856" y="1113271"/>
            <a:ext cx="418237" cy="3735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E47CBCFC-D70F-4090-F35D-B0BA3538B30C}"/>
              </a:ext>
            </a:extLst>
          </p:cNvPr>
          <p:cNvSpPr txBox="1"/>
          <p:nvPr/>
        </p:nvSpPr>
        <p:spPr>
          <a:xfrm>
            <a:off x="8527806" y="1070854"/>
            <a:ext cx="11529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PFS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24340F0B-CC11-5ABF-3B3F-53C6C725ED6F}"/>
              </a:ext>
            </a:extLst>
          </p:cNvPr>
          <p:cNvSpPr txBox="1"/>
          <p:nvPr/>
        </p:nvSpPr>
        <p:spPr>
          <a:xfrm>
            <a:off x="1031009" y="8889164"/>
            <a:ext cx="24488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.6 months (95% CI 4.0–15.6)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CR: 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E (95% CI: NE-NE)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A68ACADD-3848-40B1-3B1B-99A1193D9940}"/>
              </a:ext>
            </a:extLst>
          </p:cNvPr>
          <p:cNvSpPr txBox="1"/>
          <p:nvPr/>
        </p:nvSpPr>
        <p:spPr>
          <a:xfrm>
            <a:off x="8336914" y="8889164"/>
            <a:ext cx="2300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5 months (95% CI 2.0–7.0)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CR: 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E (95% CI: NE-NE)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351295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i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95</Words>
  <Application>Microsoft Macintosh PowerPoint</Application>
  <PresentationFormat>Personalizzato</PresentationFormat>
  <Paragraphs>14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asadeigardini.andre</dc:creator>
  <cp:lastModifiedBy>casadeigardini.andre</cp:lastModifiedBy>
  <cp:revision>4</cp:revision>
  <dcterms:created xsi:type="dcterms:W3CDTF">2025-09-21T19:42:05Z</dcterms:created>
  <dcterms:modified xsi:type="dcterms:W3CDTF">2026-03-23T10:33:10Z</dcterms:modified>
</cp:coreProperties>
</file>